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822" autoAdjust="0"/>
  </p:normalViewPr>
  <p:slideViewPr>
    <p:cSldViewPr snapToGrid="0">
      <p:cViewPr varScale="1">
        <p:scale>
          <a:sx n="100" d="100"/>
          <a:sy n="100" d="100"/>
        </p:scale>
        <p:origin x="99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C76C78-BE93-4794-9CEF-92F2858797E9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9CD689-B771-4264-AFDF-BAE11123B8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3387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9CD689-B771-4264-AFDF-BAE11123B8CC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86763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3388E-13FA-0207-3A95-409B035C12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89C8A5-9993-567A-4E33-6CD8E753F3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FDC5F-F909-6ADE-698A-1C068ED46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D13B09-2638-5451-EBC6-02AD3A6A1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B48973-9C75-0E05-86E0-1BAC3C8C1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0599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525DDE-C261-C49D-C71F-CCFF81523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319F76-AF99-BE3C-6B51-54E425F846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A48BC7-C6F1-16B5-1245-31267F7DD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6D68EC-08EE-40DC-F9C1-C4E1145FB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A972BA-81A0-F78F-8A05-0021BFB39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6368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D76FAD-CE5E-2E81-AC0E-08E27BB3F9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3B3137-1C58-7632-33EE-BC0DDD828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DEDB85-4FB9-434A-F11B-7750F9CE9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8E94D-5165-C34B-76E2-B3942C14B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B9902A-021C-31D4-D716-02D0A35C9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3265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079814-D2ED-5848-174A-F035FCD1ED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D7DB58-0A18-20C4-634F-F08DC344E8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8277E-8B32-A63A-4CD3-578FFCF34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003563-E3B3-4136-5466-F85EAE9B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94ED21-D440-D40D-9DFC-59E785C68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807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FD30F5-1C04-E2F1-31F2-CD9D9B7AE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F8055-44D6-07E7-E032-05AB313F65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3C709-FA7F-98A1-8DAE-091FD46F1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24B6D-4EBD-999B-4E42-973120D88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0CCADE-0D6B-3D50-4FAB-19C0EBCAB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9167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80EE8-8F30-48D1-1B0F-CC5DAF4F9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11DCFB-1115-BAE4-66DA-15666FEE81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7C8DBE-7D66-3594-901D-B1AE69023F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3E38BD-288A-D624-A2FD-0414DF1C5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89D01D-EA19-2C80-A97A-774F4B316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D70AC6-E627-5788-BB30-F9BFE30D0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79427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97045C-943E-F327-98E1-F704AF6819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EBCB00-EBB5-9FF1-31C0-A7E6BDCE3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CAA497-E2E6-A0F4-9EA5-5E32FF2A27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62FA7D-E9FA-CD58-9B30-CA0AC4C21E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E81142-5A35-363B-D01F-31EC8A9EFA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5EAD37-5FEC-B197-9B10-3F9F0FC23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0F1BD9-D5BF-CF1B-1C65-7CF9FB4BA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E017F6-DD44-F70B-8E11-3CCB7C74E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8244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B4E3A-4179-BBE0-D96C-96642AE54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C64EDD-2F16-9D75-7375-C71487668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145E0B-E2EC-FC83-7F16-1084A4AD8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D3D2FF-2FD5-A0D1-DEF5-64769744F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5855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111C8B-0E39-C1E9-634F-AA33AE7BB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C309CF-6444-ED75-0882-FA9666C50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B21B4F-9CDA-4D32-CB30-56F776BBF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6384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E84A7-86B8-7502-2F8A-66869AFAF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F8A7DE-44A9-A5C8-D96A-C5FBAE7DE3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3514FC-6EDB-C4A5-0ABA-D4DFC1A0E7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FEAA30-D1EC-3815-3E6E-C6117B618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0698DA-A89A-CC9D-9E5A-734652720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FAC8D5-2D6D-1B66-B8C9-AE37C797F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9594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608FA-5AA6-88FC-FD51-DF28287E5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AEFD99-283D-6C09-6AFE-A0B146BA83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ADF68F-7EFD-41E3-A7FC-B3341421F0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28BC2C-A882-89A3-FD88-17E73117A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74545A-17EF-EF27-22C7-E4DCF6A9D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E0B5E3-CA98-7F61-2E58-5E109D566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6809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32654F-E01C-6BDD-16B0-436D2AE47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A1499-A892-D05D-CB4F-3419B0B055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DC8C9C-5F61-5D5B-2307-4DFE4F8612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B9E693-D994-4C6E-9940-D3EA4684B1CE}" type="datetimeFigureOut">
              <a:rPr lang="en-AU" smtClean="0"/>
              <a:t>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92234-1E97-F6D9-4010-866130F9CA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6EB54-D596-8E43-7860-DFACE02FCD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F7A19E-149D-4FBC-9A5E-34C771341B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0675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oup of blue and red dots&#10;&#10;AI-generated content may be incorrect.">
            <a:extLst>
              <a:ext uri="{FF2B5EF4-FFF2-40B4-BE49-F238E27FC236}">
                <a16:creationId xmlns:a16="http://schemas.microsoft.com/office/drawing/2014/main" id="{48C9DA19-C432-4AD7-C9D3-D27D2A63F1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" b="20196"/>
          <a:stretch/>
        </p:blipFill>
        <p:spPr>
          <a:xfrm>
            <a:off x="2600672" y="1792605"/>
            <a:ext cx="6990655" cy="25877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28774FC-321E-404B-28C4-DDB05CDC94CA}"/>
              </a:ext>
            </a:extLst>
          </p:cNvPr>
          <p:cNvSpPr txBox="1"/>
          <p:nvPr/>
        </p:nvSpPr>
        <p:spPr>
          <a:xfrm>
            <a:off x="0" y="70604"/>
            <a:ext cx="11399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4</a:t>
            </a:r>
            <a:endParaRPr lang="en-AU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49757E-B508-AA30-D46F-D70B69686E2E}"/>
              </a:ext>
            </a:extLst>
          </p:cNvPr>
          <p:cNvSpPr txBox="1"/>
          <p:nvPr/>
        </p:nvSpPr>
        <p:spPr>
          <a:xfrm rot="16200000">
            <a:off x="1464980" y="2795994"/>
            <a:ext cx="1323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SNRPN </a:t>
            </a:r>
            <a:r>
              <a:rPr lang="en-US" sz="1600" b="1" dirty="0"/>
              <a:t> MR</a:t>
            </a:r>
            <a:endParaRPr lang="en-AU" sz="1600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F7E655E-CC42-2443-B4D5-2A165857B7DC}"/>
              </a:ext>
            </a:extLst>
          </p:cNvPr>
          <p:cNvGrpSpPr/>
          <p:nvPr/>
        </p:nvGrpSpPr>
        <p:grpSpPr>
          <a:xfrm>
            <a:off x="2239398" y="1724357"/>
            <a:ext cx="530352" cy="2833520"/>
            <a:chOff x="2267735" y="232355"/>
            <a:chExt cx="530352" cy="1660602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8B5C460-09C7-EC6B-44FD-FF6E3C3DB9C0}"/>
                </a:ext>
              </a:extLst>
            </p:cNvPr>
            <p:cNvSpPr txBox="1"/>
            <p:nvPr/>
          </p:nvSpPr>
          <p:spPr>
            <a:xfrm>
              <a:off x="2267735" y="232355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.0</a:t>
              </a:r>
              <a:endParaRPr lang="en-AU" sz="14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C3B696F-6AF9-58F6-B5E1-8D9AA75AD536}"/>
                </a:ext>
              </a:extLst>
            </p:cNvPr>
            <p:cNvSpPr txBox="1"/>
            <p:nvPr/>
          </p:nvSpPr>
          <p:spPr>
            <a:xfrm>
              <a:off x="2267735" y="502920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0.9</a:t>
              </a:r>
              <a:endParaRPr lang="en-AU" sz="1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64EFFF4-1700-FB18-3DF1-4A160A4C8270}"/>
                </a:ext>
              </a:extLst>
            </p:cNvPr>
            <p:cNvSpPr txBox="1"/>
            <p:nvPr/>
          </p:nvSpPr>
          <p:spPr>
            <a:xfrm>
              <a:off x="2267735" y="773485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0.8</a:t>
              </a:r>
              <a:endParaRPr lang="en-AU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7EECD5D-4906-7864-E785-946BE69C7176}"/>
                </a:ext>
              </a:extLst>
            </p:cNvPr>
            <p:cNvSpPr txBox="1"/>
            <p:nvPr/>
          </p:nvSpPr>
          <p:spPr>
            <a:xfrm>
              <a:off x="2267735" y="1044050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0.7</a:t>
              </a:r>
              <a:endParaRPr lang="en-AU" sz="14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8A5DA9A-0DDD-AEAC-FA37-A66120DCB334}"/>
                </a:ext>
              </a:extLst>
            </p:cNvPr>
            <p:cNvSpPr txBox="1"/>
            <p:nvPr/>
          </p:nvSpPr>
          <p:spPr>
            <a:xfrm>
              <a:off x="2267735" y="1314615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0.6</a:t>
              </a:r>
              <a:endParaRPr lang="en-AU" sz="14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5F270B9-0E8F-E50D-7F09-BC03F6CDB615}"/>
                </a:ext>
              </a:extLst>
            </p:cNvPr>
            <p:cNvSpPr txBox="1"/>
            <p:nvPr/>
          </p:nvSpPr>
          <p:spPr>
            <a:xfrm>
              <a:off x="2267735" y="1585180"/>
              <a:ext cx="5303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0.5</a:t>
              </a:r>
              <a:endParaRPr lang="en-AU" sz="1400" dirty="0"/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07E4D50D-0A38-5BC6-1441-AF24E6FAD811}"/>
              </a:ext>
            </a:extLst>
          </p:cNvPr>
          <p:cNvSpPr txBox="1"/>
          <p:nvPr/>
        </p:nvSpPr>
        <p:spPr>
          <a:xfrm>
            <a:off x="3086634" y="4392292"/>
            <a:ext cx="1760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Interstitial</a:t>
            </a:r>
          </a:p>
          <a:p>
            <a:pPr algn="ctr"/>
            <a:r>
              <a:rPr lang="en-US" sz="1000" b="1" dirty="0"/>
              <a:t>(3 copies of 15q11.2-q13.1</a:t>
            </a:r>
            <a:r>
              <a:rPr lang="en-AU" sz="1000" dirty="0">
                <a:solidFill>
                  <a:srgbClr val="001D35"/>
                </a:solidFill>
                <a:latin typeface="Google Sans"/>
              </a:rPr>
              <a:t>)</a:t>
            </a:r>
            <a:r>
              <a:rPr lang="en-US" sz="1000" b="1" dirty="0"/>
              <a:t> </a:t>
            </a:r>
            <a:endParaRPr lang="en-AU" sz="1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43FD82F-4F57-5B06-EEB3-1669478A9163}"/>
              </a:ext>
            </a:extLst>
          </p:cNvPr>
          <p:cNvSpPr txBox="1"/>
          <p:nvPr/>
        </p:nvSpPr>
        <p:spPr>
          <a:xfrm>
            <a:off x="5312383" y="4380357"/>
            <a:ext cx="17716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/>
              <a:t>Isodicentric</a:t>
            </a:r>
            <a:endParaRPr lang="en-US" sz="1400" b="1" dirty="0"/>
          </a:p>
          <a:p>
            <a:pPr algn="ctr"/>
            <a:r>
              <a:rPr lang="en-US" sz="1000" b="1" dirty="0"/>
              <a:t>(4 copies of 15q11.2-q13.1</a:t>
            </a:r>
            <a:r>
              <a:rPr lang="en-AU" sz="1000" dirty="0">
                <a:solidFill>
                  <a:srgbClr val="001D35"/>
                </a:solidFill>
                <a:latin typeface="Google Sans"/>
              </a:rPr>
              <a:t>)</a:t>
            </a:r>
            <a:r>
              <a:rPr lang="en-US" sz="1400" b="1" dirty="0"/>
              <a:t> </a:t>
            </a:r>
            <a:endParaRPr lang="en-AU" sz="14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24C9CE1-37E9-5764-AAF1-7812C5377704}"/>
              </a:ext>
            </a:extLst>
          </p:cNvPr>
          <p:cNvSpPr txBox="1"/>
          <p:nvPr/>
        </p:nvSpPr>
        <p:spPr>
          <a:xfrm>
            <a:off x="7407316" y="4380357"/>
            <a:ext cx="1760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/>
              <a:t>Hexasomy</a:t>
            </a:r>
            <a:endParaRPr lang="en-US" sz="1400" b="1" dirty="0"/>
          </a:p>
          <a:p>
            <a:pPr algn="ctr"/>
            <a:r>
              <a:rPr lang="en-US" sz="1000" b="1" dirty="0"/>
              <a:t>(6 copies of 15q11.2-q13.1</a:t>
            </a:r>
            <a:r>
              <a:rPr lang="en-AU" sz="1000" dirty="0">
                <a:solidFill>
                  <a:srgbClr val="001D35"/>
                </a:solidFill>
                <a:latin typeface="Google Sans"/>
              </a:rPr>
              <a:t>)</a:t>
            </a:r>
            <a:r>
              <a:rPr lang="en-US" sz="1000" b="1" dirty="0"/>
              <a:t> </a:t>
            </a:r>
            <a:endParaRPr lang="en-AU" sz="1000" b="1" dirty="0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8791B92-3AAA-A169-827A-F4E7EEE6065C}"/>
              </a:ext>
            </a:extLst>
          </p:cNvPr>
          <p:cNvGrpSpPr/>
          <p:nvPr/>
        </p:nvGrpSpPr>
        <p:grpSpPr>
          <a:xfrm>
            <a:off x="2715913" y="1804540"/>
            <a:ext cx="1226827" cy="588193"/>
            <a:chOff x="3223336" y="1932257"/>
            <a:chExt cx="1226827" cy="588193"/>
          </a:xfrm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C0127C2-1959-5047-D425-71B1BB76FDB6}"/>
                </a:ext>
              </a:extLst>
            </p:cNvPr>
            <p:cNvSpPr/>
            <p:nvPr/>
          </p:nvSpPr>
          <p:spPr>
            <a:xfrm>
              <a:off x="3223336" y="1963111"/>
              <a:ext cx="1168231" cy="526259"/>
            </a:xfrm>
            <a:prstGeom prst="rect">
              <a:avLst/>
            </a:prstGeom>
            <a:solidFill>
              <a:schemeClr val="bg1"/>
            </a:solidFill>
            <a:ln w="31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BF901D7-79B4-2E72-748C-3AEED1DDC906}"/>
                </a:ext>
              </a:extLst>
            </p:cNvPr>
            <p:cNvSpPr txBox="1"/>
            <p:nvPr/>
          </p:nvSpPr>
          <p:spPr>
            <a:xfrm>
              <a:off x="3315074" y="2212673"/>
              <a:ext cx="8057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/>
                <a:t>IsoPure</a:t>
              </a:r>
              <a:endParaRPr lang="en-AU" sz="1400" b="1" dirty="0"/>
            </a:p>
          </p:txBody>
        </p:sp>
        <p:pic>
          <p:nvPicPr>
            <p:cNvPr id="29" name="Picture 28" descr="A group of blue and red dots&#10;&#10;AI-generated content may be incorrect.">
              <a:extLst>
                <a:ext uri="{FF2B5EF4-FFF2-40B4-BE49-F238E27FC236}">
                  <a16:creationId xmlns:a16="http://schemas.microsoft.com/office/drawing/2014/main" id="{62CABE07-F681-BCDA-BF93-B5856E46472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51" t="27680" r="81740" b="66578"/>
            <a:stretch/>
          </p:blipFill>
          <p:spPr>
            <a:xfrm>
              <a:off x="3246941" y="1993063"/>
              <a:ext cx="125936" cy="186166"/>
            </a:xfrm>
            <a:prstGeom prst="rect">
              <a:avLst/>
            </a:prstGeom>
          </p:spPr>
        </p:pic>
        <p:pic>
          <p:nvPicPr>
            <p:cNvPr id="30" name="Picture 29" descr="A group of blue and red dots&#10;&#10;AI-generated content may be incorrect.">
              <a:extLst>
                <a:ext uri="{FF2B5EF4-FFF2-40B4-BE49-F238E27FC236}">
                  <a16:creationId xmlns:a16="http://schemas.microsoft.com/office/drawing/2014/main" id="{A892E334-F875-6063-C7D5-6016186E81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41" t="46079" r="69928" b="49203"/>
            <a:stretch/>
          </p:blipFill>
          <p:spPr>
            <a:xfrm>
              <a:off x="3246941" y="2290740"/>
              <a:ext cx="142362" cy="152974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0DF0F19-7B0C-AE0B-3BA4-716398B89B56}"/>
                </a:ext>
              </a:extLst>
            </p:cNvPr>
            <p:cNvSpPr txBox="1"/>
            <p:nvPr/>
          </p:nvSpPr>
          <p:spPr>
            <a:xfrm>
              <a:off x="3318122" y="1932257"/>
              <a:ext cx="11320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/>
                <a:t>Qiacube</a:t>
              </a:r>
              <a:r>
                <a:rPr lang="en-US" sz="1400" b="1" dirty="0"/>
                <a:t> HT</a:t>
              </a:r>
              <a:endParaRPr lang="en-AU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16917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35</Words>
  <Application>Microsoft Office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Google San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 Godler</dc:creator>
  <cp:lastModifiedBy>David</cp:lastModifiedBy>
  <cp:revision>4</cp:revision>
  <dcterms:created xsi:type="dcterms:W3CDTF">2025-06-18T02:07:51Z</dcterms:created>
  <dcterms:modified xsi:type="dcterms:W3CDTF">2025-07-01T04:19:31Z</dcterms:modified>
</cp:coreProperties>
</file>